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sldIdLst>
    <p:sldId id="257" r:id="rId2"/>
    <p:sldId id="258" r:id="rId3"/>
  </p:sldIdLst>
  <p:sldSz cx="7559675" cy="104648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71"/>
    <p:restoredTop sz="94592"/>
  </p:normalViewPr>
  <p:slideViewPr>
    <p:cSldViewPr snapToGrid="0" snapToObjects="1">
      <p:cViewPr varScale="1">
        <p:scale>
          <a:sx n="58" d="100"/>
          <a:sy n="58" d="100"/>
        </p:scale>
        <p:origin x="1306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12643"/>
            <a:ext cx="6425724" cy="3643301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96443"/>
            <a:ext cx="5669756" cy="2526570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4731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98873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7154"/>
            <a:ext cx="1630055" cy="8868434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7154"/>
            <a:ext cx="4795669" cy="8868434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200470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922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8936"/>
            <a:ext cx="6520220" cy="4353065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003183"/>
            <a:ext cx="6520220" cy="2289174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35577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85769"/>
            <a:ext cx="3212862" cy="663981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85769"/>
            <a:ext cx="3212862" cy="6639819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6026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7156"/>
            <a:ext cx="6520220" cy="2022711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65330"/>
            <a:ext cx="3198096" cy="125722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22559"/>
            <a:ext cx="3198096" cy="562240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65330"/>
            <a:ext cx="3213847" cy="1257229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22559"/>
            <a:ext cx="3213847" cy="562240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7305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30586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9951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7653"/>
            <a:ext cx="2438192" cy="2441787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6740"/>
            <a:ext cx="3827085" cy="7436791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9440"/>
            <a:ext cx="2438192" cy="581620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059081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7653"/>
            <a:ext cx="2438192" cy="2441787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6740"/>
            <a:ext cx="3827085" cy="7436791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9440"/>
            <a:ext cx="2438192" cy="5816201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53409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7156"/>
            <a:ext cx="6520220" cy="202271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85769"/>
            <a:ext cx="6520220" cy="66398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
Secondo livello
Terzo livello
Quarto livello
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99321"/>
            <a:ext cx="1700927" cy="5571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04B5B-0FE5-224C-BDB0-4D63A8FB74DA}" type="datetimeFigureOut">
              <a:rPr lang="it-IT" smtClean="0"/>
              <a:t>22/08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99321"/>
            <a:ext cx="2551390" cy="5571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99321"/>
            <a:ext cx="1700927" cy="55715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5E5DC0-2D50-8041-A23C-366EF54EE37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56973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image" Target="../media/image2.svg"/><Relationship Id="rId7" Type="http://schemas.openxmlformats.org/officeDocument/2006/relationships/image" Target="../media/image6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openxmlformats.org/officeDocument/2006/relationships/image" Target="../media/image4.svg"/><Relationship Id="rId4" Type="http://schemas.openxmlformats.org/officeDocument/2006/relationships/image" Target="../media/image2.png"/><Relationship Id="rId9" Type="http://schemas.openxmlformats.org/officeDocument/2006/relationships/image" Target="../media/image8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svg"/><Relationship Id="rId7" Type="http://schemas.openxmlformats.org/officeDocument/2006/relationships/image" Target="../media/image14.sv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5" Type="http://schemas.openxmlformats.org/officeDocument/2006/relationships/image" Target="../media/image12.sv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Elemento grafico 15">
            <a:extLst>
              <a:ext uri="{FF2B5EF4-FFF2-40B4-BE49-F238E27FC236}">
                <a16:creationId xmlns:a16="http://schemas.microsoft.com/office/drawing/2014/main" id="{33B3EADB-4A64-E64C-834B-6A3B7DD0974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xmlns="" r:embed="rId3"/>
              </a:ext>
            </a:extLst>
          </a:blip>
          <a:srcRect l="16667" t="16667" r="16667" b="16667"/>
          <a:stretch/>
        </p:blipFill>
        <p:spPr>
          <a:xfrm>
            <a:off x="0" y="19214"/>
            <a:ext cx="3779837" cy="3779837"/>
          </a:xfrm>
          <a:prstGeom prst="rect">
            <a:avLst/>
          </a:prstGeom>
        </p:spPr>
      </p:pic>
      <p:pic>
        <p:nvPicPr>
          <p:cNvPr id="18" name="Elemento grafico 17">
            <a:extLst>
              <a:ext uri="{FF2B5EF4-FFF2-40B4-BE49-F238E27FC236}">
                <a16:creationId xmlns:a16="http://schemas.microsoft.com/office/drawing/2014/main" id="{576F4B0A-687B-5948-B7D4-8DE723DDE51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96DAC541-7B7A-43D3-8B79-37D633B846F1}">
                <asvg:svgBlip xmlns:asvg="http://schemas.microsoft.com/office/drawing/2016/SVG/main" xmlns="" r:embed="rId5"/>
              </a:ext>
            </a:extLst>
          </a:blip>
          <a:srcRect l="16667" t="16667" r="16667" b="16667"/>
          <a:stretch/>
        </p:blipFill>
        <p:spPr>
          <a:xfrm>
            <a:off x="3779837" y="19214"/>
            <a:ext cx="3779837" cy="3779837"/>
          </a:xfrm>
          <a:prstGeom prst="rect">
            <a:avLst/>
          </a:prstGeom>
        </p:spPr>
      </p:pic>
      <p:pic>
        <p:nvPicPr>
          <p:cNvPr id="20" name="Elemento grafico 19">
            <a:extLst>
              <a:ext uri="{FF2B5EF4-FFF2-40B4-BE49-F238E27FC236}">
                <a16:creationId xmlns:a16="http://schemas.microsoft.com/office/drawing/2014/main" id="{C13B3BD0-8B8A-3446-8202-331021232EE2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xmlns="" r:embed="rId7"/>
              </a:ext>
            </a:extLst>
          </a:blip>
          <a:srcRect l="16667" t="16667" r="16667" b="16667"/>
          <a:stretch/>
        </p:blipFill>
        <p:spPr>
          <a:xfrm>
            <a:off x="3781696" y="3742338"/>
            <a:ext cx="3779838" cy="3779838"/>
          </a:xfrm>
          <a:prstGeom prst="rect">
            <a:avLst/>
          </a:prstGeom>
        </p:spPr>
      </p:pic>
      <p:pic>
        <p:nvPicPr>
          <p:cNvPr id="22" name="Elemento grafico 21">
            <a:extLst>
              <a:ext uri="{FF2B5EF4-FFF2-40B4-BE49-F238E27FC236}">
                <a16:creationId xmlns:a16="http://schemas.microsoft.com/office/drawing/2014/main" id="{D78E218D-4B41-F949-85B6-60B4D6C47528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96DAC541-7B7A-43D3-8B79-37D633B846F1}">
                <asvg:svgBlip xmlns:asvg="http://schemas.microsoft.com/office/drawing/2016/SVG/main" xmlns="" r:embed="rId9"/>
              </a:ext>
            </a:extLst>
          </a:blip>
          <a:srcRect l="16667" t="16667" r="16667" b="16667"/>
          <a:stretch/>
        </p:blipFill>
        <p:spPr>
          <a:xfrm>
            <a:off x="-1" y="3742338"/>
            <a:ext cx="3779838" cy="3779838"/>
          </a:xfrm>
          <a:prstGeom prst="rect">
            <a:avLst/>
          </a:prstGeom>
        </p:spPr>
      </p:pic>
      <p:sp>
        <p:nvSpPr>
          <p:cNvPr id="9" name="CasellaDiTesto 8"/>
          <p:cNvSpPr txBox="1"/>
          <p:nvPr/>
        </p:nvSpPr>
        <p:spPr>
          <a:xfrm>
            <a:off x="342000" y="403200"/>
            <a:ext cx="130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asellaDiTesto 10"/>
          <p:cNvSpPr txBox="1"/>
          <p:nvPr/>
        </p:nvSpPr>
        <p:spPr>
          <a:xfrm>
            <a:off x="4176000" y="342000"/>
            <a:ext cx="130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342000" y="4024823"/>
            <a:ext cx="130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4176000" y="4024823"/>
            <a:ext cx="130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297522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Elemento grafico 2">
            <a:extLst>
              <a:ext uri="{FF2B5EF4-FFF2-40B4-BE49-F238E27FC236}">
                <a16:creationId xmlns:a16="http://schemas.microsoft.com/office/drawing/2014/main" id="{B11852C4-25CB-DB4F-9287-BD7DE8012BA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:asvg="http://schemas.microsoft.com/office/drawing/2016/SVG/main" xmlns="" r:embed="rId3"/>
              </a:ext>
            </a:extLst>
          </a:blip>
          <a:srcRect l="16667" t="16667" r="16667" b="16667"/>
          <a:stretch/>
        </p:blipFill>
        <p:spPr>
          <a:xfrm>
            <a:off x="0" y="11926"/>
            <a:ext cx="3780000" cy="3780000"/>
          </a:xfrm>
          <a:prstGeom prst="rect">
            <a:avLst/>
          </a:prstGeom>
        </p:spPr>
      </p:pic>
      <p:pic>
        <p:nvPicPr>
          <p:cNvPr id="11" name="Elemento grafico 10">
            <a:extLst>
              <a:ext uri="{FF2B5EF4-FFF2-40B4-BE49-F238E27FC236}">
                <a16:creationId xmlns:a16="http://schemas.microsoft.com/office/drawing/2014/main" id="{53373889-1594-624C-B4C9-193E6D0FE67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96DAC541-7B7A-43D3-8B79-37D633B846F1}">
                <asvg:svgBlip xmlns:asvg="http://schemas.microsoft.com/office/drawing/2016/SVG/main" xmlns="" r:embed="rId5"/>
              </a:ext>
            </a:extLst>
          </a:blip>
          <a:srcRect l="16667" t="16667" r="16667" b="16667"/>
          <a:stretch/>
        </p:blipFill>
        <p:spPr>
          <a:xfrm>
            <a:off x="3775920" y="11926"/>
            <a:ext cx="3780000" cy="3780000"/>
          </a:xfrm>
          <a:prstGeom prst="rect">
            <a:avLst/>
          </a:prstGeom>
        </p:spPr>
      </p:pic>
      <p:pic>
        <p:nvPicPr>
          <p:cNvPr id="13" name="Elemento grafico 12">
            <a:extLst>
              <a:ext uri="{FF2B5EF4-FFF2-40B4-BE49-F238E27FC236}">
                <a16:creationId xmlns:a16="http://schemas.microsoft.com/office/drawing/2014/main" id="{3884B5E3-C8A1-924A-AA00-3F8D27181D7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96DAC541-7B7A-43D3-8B79-37D633B846F1}">
                <asvg:svgBlip xmlns:asvg="http://schemas.microsoft.com/office/drawing/2016/SVG/main" xmlns="" r:embed="rId7"/>
              </a:ext>
            </a:extLst>
          </a:blip>
          <a:srcRect l="16667" t="16667" r="16667" b="16667"/>
          <a:stretch/>
        </p:blipFill>
        <p:spPr>
          <a:xfrm>
            <a:off x="0" y="3607524"/>
            <a:ext cx="3780000" cy="3780000"/>
          </a:xfrm>
          <a:prstGeom prst="rect">
            <a:avLst/>
          </a:prstGeom>
        </p:spPr>
      </p:pic>
      <p:sp>
        <p:nvSpPr>
          <p:cNvPr id="8" name="CasellaDiTesto 7"/>
          <p:cNvSpPr txBox="1"/>
          <p:nvPr/>
        </p:nvSpPr>
        <p:spPr>
          <a:xfrm>
            <a:off x="4174572" y="342831"/>
            <a:ext cx="130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asellaDiTesto 8"/>
          <p:cNvSpPr txBox="1"/>
          <p:nvPr/>
        </p:nvSpPr>
        <p:spPr>
          <a:xfrm>
            <a:off x="402772" y="342831"/>
            <a:ext cx="1306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asellaDiTesto 9"/>
          <p:cNvSpPr txBox="1"/>
          <p:nvPr/>
        </p:nvSpPr>
        <p:spPr>
          <a:xfrm>
            <a:off x="402772" y="3923592"/>
            <a:ext cx="130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Tabella 11">
            <a:extLst>
              <a:ext uri="{FF2B5EF4-FFF2-40B4-BE49-F238E27FC236}">
                <a16:creationId xmlns:a16="http://schemas.microsoft.com/office/drawing/2014/main" id="{5986425F-A74B-1E43-9478-13F4A5E2C22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36100918"/>
              </p:ext>
            </p:extLst>
          </p:nvPr>
        </p:nvGraphicFramePr>
        <p:xfrm>
          <a:off x="463432" y="7383648"/>
          <a:ext cx="6633136" cy="2509276"/>
        </p:xfrm>
        <a:graphic>
          <a:graphicData uri="http://schemas.openxmlformats.org/drawingml/2006/table">
            <a:tbl>
              <a:tblPr/>
              <a:tblGrid>
                <a:gridCol w="239607">
                  <a:extLst>
                    <a:ext uri="{9D8B030D-6E8A-4147-A177-3AD203B41FA5}">
                      <a16:colId xmlns:a16="http://schemas.microsoft.com/office/drawing/2014/main" val="3042274255"/>
                    </a:ext>
                  </a:extLst>
                </a:gridCol>
                <a:gridCol w="775060">
                  <a:extLst>
                    <a:ext uri="{9D8B030D-6E8A-4147-A177-3AD203B41FA5}">
                      <a16:colId xmlns:a16="http://schemas.microsoft.com/office/drawing/2014/main" val="2551496013"/>
                    </a:ext>
                  </a:extLst>
                </a:gridCol>
                <a:gridCol w="930247">
                  <a:extLst>
                    <a:ext uri="{9D8B030D-6E8A-4147-A177-3AD203B41FA5}">
                      <a16:colId xmlns:a16="http://schemas.microsoft.com/office/drawing/2014/main" val="1374318305"/>
                    </a:ext>
                  </a:extLst>
                </a:gridCol>
                <a:gridCol w="891284">
                  <a:extLst>
                    <a:ext uri="{9D8B030D-6E8A-4147-A177-3AD203B41FA5}">
                      <a16:colId xmlns:a16="http://schemas.microsoft.com/office/drawing/2014/main" val="2874516563"/>
                    </a:ext>
                  </a:extLst>
                </a:gridCol>
                <a:gridCol w="969210">
                  <a:extLst>
                    <a:ext uri="{9D8B030D-6E8A-4147-A177-3AD203B41FA5}">
                      <a16:colId xmlns:a16="http://schemas.microsoft.com/office/drawing/2014/main" val="2515233125"/>
                    </a:ext>
                  </a:extLst>
                </a:gridCol>
                <a:gridCol w="1006199">
                  <a:extLst>
                    <a:ext uri="{9D8B030D-6E8A-4147-A177-3AD203B41FA5}">
                      <a16:colId xmlns:a16="http://schemas.microsoft.com/office/drawing/2014/main" val="1197581127"/>
                    </a:ext>
                  </a:extLst>
                </a:gridCol>
                <a:gridCol w="969210">
                  <a:extLst>
                    <a:ext uri="{9D8B030D-6E8A-4147-A177-3AD203B41FA5}">
                      <a16:colId xmlns:a16="http://schemas.microsoft.com/office/drawing/2014/main" val="453478218"/>
                    </a:ext>
                  </a:extLst>
                </a:gridCol>
                <a:gridCol w="852319">
                  <a:extLst>
                    <a:ext uri="{9D8B030D-6E8A-4147-A177-3AD203B41FA5}">
                      <a16:colId xmlns:a16="http://schemas.microsoft.com/office/drawing/2014/main" val="1443967034"/>
                    </a:ext>
                  </a:extLst>
                </a:gridCol>
              </a:tblGrid>
              <a:tr h="441112">
                <a:tc>
                  <a:txBody>
                    <a:bodyPr/>
                    <a:lstStyle/>
                    <a:p>
                      <a:pPr algn="l" fontAlgn="b"/>
                      <a:endParaRPr lang="en-GB" sz="18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biotic Stress Respons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uster Related Trait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rry Morphology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rry Metabolite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athogen Resistanc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s Related Trait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egetative Trait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9751841"/>
                  </a:ext>
                </a:extLst>
              </a:tr>
              <a:tr h="296485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B9BD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rought Stres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ertility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rry Weigh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nthocyanins</a:t>
                      </a:r>
                      <a:endParaRPr lang="en-GB" sz="9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wny Mildew Resistanc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Number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owth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14350506"/>
                  </a:ext>
                </a:extLst>
              </a:tr>
              <a:tr h="296485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D7D3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hlorosi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rry Number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rry Firmnes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erpenols</a:t>
                      </a:r>
                      <a:endParaRPr lang="en-GB" sz="9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owdery Mildew Resistanc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Weigh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af Morphology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2108369"/>
                  </a:ext>
                </a:extLst>
              </a:tr>
              <a:tr h="296485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33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baseline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duncle Length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rry Diameter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And Skin Tannin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hylloxera</a:t>
                      </a:r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Resistanc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Percent Dry Matter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ater Use Efficiency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336275"/>
                  </a:ext>
                </a:extLst>
              </a:tr>
              <a:tr h="296485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baseline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uster Architectur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rry Volum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lavonol</a:t>
                      </a:r>
                      <a:endParaRPr lang="en-GB" sz="9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lack Rot Resistanc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eed Response To 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eaf Are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1055704"/>
                  </a:ext>
                </a:extLst>
              </a:tr>
              <a:tr h="44111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baseline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uster Weight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erry Response To 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otrytis Resistance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900" b="0" i="0" u="none" strike="noStrike" baseline="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9214806"/>
                  </a:ext>
                </a:extLst>
              </a:tr>
              <a:tr h="441112">
                <a:tc>
                  <a:txBody>
                    <a:bodyPr/>
                    <a:lstStyle/>
                    <a:p>
                      <a:pPr algn="l" rtl="0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0AD4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luster Response To Ga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GB" sz="9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70287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248575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92</Words>
  <Application>Microsoft Office PowerPoint</Application>
  <PresentationFormat>Personalizzato</PresentationFormat>
  <Paragraphs>56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ietro Delfino</dc:creator>
  <cp:lastModifiedBy>Diana Bellin</cp:lastModifiedBy>
  <cp:revision>18</cp:revision>
  <dcterms:created xsi:type="dcterms:W3CDTF">2019-02-15T14:21:09Z</dcterms:created>
  <dcterms:modified xsi:type="dcterms:W3CDTF">2019-08-22T02:50:40Z</dcterms:modified>
</cp:coreProperties>
</file>